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72" r:id="rId5"/>
    <p:sldId id="274" r:id="rId6"/>
    <p:sldId id="273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>
        <p:scale>
          <a:sx n="100" d="100"/>
          <a:sy n="100" d="100"/>
        </p:scale>
        <p:origin x="1044" y="-3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05C9-4A4B-4228-863A-3208F5E5947C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91D40-1AAE-407F-88F6-D7AAD39340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561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05C9-4A4B-4228-863A-3208F5E5947C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91D40-1AAE-407F-88F6-D7AAD39340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6054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05C9-4A4B-4228-863A-3208F5E5947C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91D40-1AAE-407F-88F6-D7AAD39340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564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05C9-4A4B-4228-863A-3208F5E5947C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91D40-1AAE-407F-88F6-D7AAD39340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590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05C9-4A4B-4228-863A-3208F5E5947C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91D40-1AAE-407F-88F6-D7AAD39340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93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05C9-4A4B-4228-863A-3208F5E5947C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91D40-1AAE-407F-88F6-D7AAD39340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93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05C9-4A4B-4228-863A-3208F5E5947C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91D40-1AAE-407F-88F6-D7AAD39340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48690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05C9-4A4B-4228-863A-3208F5E5947C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91D40-1AAE-407F-88F6-D7AAD39340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2953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05C9-4A4B-4228-863A-3208F5E5947C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91D40-1AAE-407F-88F6-D7AAD39340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503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05C9-4A4B-4228-863A-3208F5E5947C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91D40-1AAE-407F-88F6-D7AAD39340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527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05C9-4A4B-4228-863A-3208F5E5947C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791D40-1AAE-407F-88F6-D7AAD39340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796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BA05C9-4A4B-4228-863A-3208F5E5947C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791D40-1AAE-407F-88F6-D7AAD39340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860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5" name="Picture 3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477" r="2814"/>
          <a:stretch/>
        </p:blipFill>
        <p:spPr bwMode="auto">
          <a:xfrm>
            <a:off x="1487316" y="1287524"/>
            <a:ext cx="3655353" cy="2008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96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0798"/>
          <a:stretch/>
        </p:blipFill>
        <p:spPr bwMode="auto">
          <a:xfrm>
            <a:off x="1487315" y="1025559"/>
            <a:ext cx="3653000" cy="2290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7" name="Group 6">
            <a:extLst>
              <a:ext uri="{FF2B5EF4-FFF2-40B4-BE49-F238E27FC236}">
                <a16:creationId xmlns:a16="http://schemas.microsoft.com/office/drawing/2014/main" id="{DBDF727E-CEC5-7446-9EC0-F2B5DE5AFF7B}"/>
              </a:ext>
            </a:extLst>
          </p:cNvPr>
          <p:cNvGrpSpPr/>
          <p:nvPr/>
        </p:nvGrpSpPr>
        <p:grpSpPr>
          <a:xfrm>
            <a:off x="1481596" y="805489"/>
            <a:ext cx="4481550" cy="716886"/>
            <a:chOff x="1481596" y="4060753"/>
            <a:chExt cx="4481550" cy="716886"/>
          </a:xfrm>
        </p:grpSpPr>
        <p:sp>
          <p:nvSpPr>
            <p:cNvPr id="5" name="TextBox 4"/>
            <p:cNvSpPr txBox="1"/>
            <p:nvPr/>
          </p:nvSpPr>
          <p:spPr>
            <a:xfrm>
              <a:off x="5144279" y="4558668"/>
              <a:ext cx="536182" cy="2189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23" dirty="0"/>
                <a:t>TUB</a:t>
              </a:r>
              <a:endParaRPr lang="en-US" sz="823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44277" y="4315726"/>
              <a:ext cx="818869" cy="2189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23" i="1" dirty="0"/>
                <a:t>WP:AnAXE1 </a:t>
              </a:r>
              <a:endParaRPr lang="en-US" sz="823" i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481596" y="4112027"/>
              <a:ext cx="3655353" cy="2189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23" dirty="0"/>
                <a:t>12       11        10        9         8          7          6          5        4          3         2         1        M     </a:t>
              </a:r>
              <a:endParaRPr lang="en-US" sz="823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144278" y="4105409"/>
              <a:ext cx="658754" cy="2189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23" i="1" dirty="0"/>
                <a:t>Line #</a:t>
              </a:r>
              <a:endParaRPr lang="en-US" sz="823" i="1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4613757" y="4060753"/>
              <a:ext cx="280328" cy="684090"/>
            </a:xfrm>
            <a:prstGeom prst="rect">
              <a:avLst/>
            </a:prstGeom>
            <a:noFill/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23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3507231" y="4060753"/>
              <a:ext cx="280328" cy="684090"/>
            </a:xfrm>
            <a:prstGeom prst="rect">
              <a:avLst/>
            </a:prstGeom>
            <a:noFill/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23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2669332" y="4060753"/>
              <a:ext cx="280328" cy="684090"/>
            </a:xfrm>
            <a:prstGeom prst="rect">
              <a:avLst/>
            </a:prstGeom>
            <a:noFill/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23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2110218" y="4060753"/>
              <a:ext cx="280328" cy="684090"/>
            </a:xfrm>
            <a:prstGeom prst="rect">
              <a:avLst/>
            </a:prstGeom>
            <a:noFill/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23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673097" y="1789288"/>
            <a:ext cx="5541967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. Transgene (AnAXE1) expression levels in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ultivated aspen transgenic lines carrying an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WP:AnAXE1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nstruct, determined by semi-q RT-PCR analysis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 tubulin gene (TUB, Potri.001G464400) was used as the reference. Primer sequences: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UBfo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:  ATTCCCTCGCCTTCATTTCT;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UBrev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: CCTCTTTCGTGCTCATCTTACC (200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TUB product); AnAxe1_1F: CTGGACGATTAGCGAGTACG; AnAxe1_1R:  CGCAGGTGGAATTCCATCC (194nt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AnAXE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roduct). M – size marker.  Lines 1, 5, 8, and 10 were selected for the field trial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70195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4230806" y="8247647"/>
            <a:ext cx="233875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. Map of the </a:t>
            </a:r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field trial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/>
              <a:t>Positions of individual trees are marked by numbers representing ID codes of their lines. “x” indicates other transgenic trees, not included in this analysis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BC3721E0-8245-4815-8EA7-DADEF68DB57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2893958"/>
              </p:ext>
            </p:extLst>
          </p:nvPr>
        </p:nvGraphicFramePr>
        <p:xfrm>
          <a:off x="609600" y="545606"/>
          <a:ext cx="3516126" cy="8871592"/>
        </p:xfrm>
        <a:graphic>
          <a:graphicData uri="http://schemas.openxmlformats.org/drawingml/2006/table">
            <a:tbl>
              <a:tblPr/>
              <a:tblGrid>
                <a:gridCol w="308481">
                  <a:extLst>
                    <a:ext uri="{9D8B030D-6E8A-4147-A177-3AD203B41FA5}">
                      <a16:colId xmlns:a16="http://schemas.microsoft.com/office/drawing/2014/main" val="3094574620"/>
                    </a:ext>
                  </a:extLst>
                </a:gridCol>
                <a:gridCol w="291052">
                  <a:extLst>
                    <a:ext uri="{9D8B030D-6E8A-4147-A177-3AD203B41FA5}">
                      <a16:colId xmlns:a16="http://schemas.microsoft.com/office/drawing/2014/main" val="4178930325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4092152701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2147007417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3316128220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2960266857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2347783098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3005706819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3298174234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3831488107"/>
                    </a:ext>
                  </a:extLst>
                </a:gridCol>
                <a:gridCol w="48509">
                  <a:extLst>
                    <a:ext uri="{9D8B030D-6E8A-4147-A177-3AD203B41FA5}">
                      <a16:colId xmlns:a16="http://schemas.microsoft.com/office/drawing/2014/main" val="873392075"/>
                    </a:ext>
                  </a:extLst>
                </a:gridCol>
                <a:gridCol w="291052">
                  <a:extLst>
                    <a:ext uri="{9D8B030D-6E8A-4147-A177-3AD203B41FA5}">
                      <a16:colId xmlns:a16="http://schemas.microsoft.com/office/drawing/2014/main" val="2403840116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3808304628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3671645185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606578140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483930899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903842429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2225683796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2575539241"/>
                    </a:ext>
                  </a:extLst>
                </a:gridCol>
                <a:gridCol w="139463">
                  <a:extLst>
                    <a:ext uri="{9D8B030D-6E8A-4147-A177-3AD203B41FA5}">
                      <a16:colId xmlns:a16="http://schemas.microsoft.com/office/drawing/2014/main" val="571017787"/>
                    </a:ext>
                  </a:extLst>
                </a:gridCol>
                <a:gridCol w="54572">
                  <a:extLst>
                    <a:ext uri="{9D8B030D-6E8A-4147-A177-3AD203B41FA5}">
                      <a16:colId xmlns:a16="http://schemas.microsoft.com/office/drawing/2014/main" val="3195575561"/>
                    </a:ext>
                  </a:extLst>
                </a:gridCol>
                <a:gridCol w="291052">
                  <a:extLst>
                    <a:ext uri="{9D8B030D-6E8A-4147-A177-3AD203B41FA5}">
                      <a16:colId xmlns:a16="http://schemas.microsoft.com/office/drawing/2014/main" val="3229152764"/>
                    </a:ext>
                  </a:extLst>
                </a:gridCol>
              </a:tblGrid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71267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w 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w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5999138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ck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 1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 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ck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991844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 2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 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 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0847322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 3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 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7836836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 4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 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3470563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 5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 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343666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 6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B 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2673623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 7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 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9913487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 8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 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0023265"/>
                  </a:ext>
                </a:extLst>
              </a:tr>
              <a:tr h="90954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 9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 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0078458"/>
                  </a:ext>
                </a:extLst>
              </a:tr>
              <a:tr h="90954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0217316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ck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 1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 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ck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7264886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 2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 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5736991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 3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 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0182587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 4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 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8755482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 5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 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8935475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 6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D 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7123698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 7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 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9669120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 8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 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9355384"/>
                  </a:ext>
                </a:extLst>
              </a:tr>
              <a:tr h="90954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 9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 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3025466"/>
                  </a:ext>
                </a:extLst>
              </a:tr>
              <a:tr h="90954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3437563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ck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 1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 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ck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1291535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 2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 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2944054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 3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 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2012518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 4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 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7795796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 5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 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9024447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E 6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 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8030787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 7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 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9062625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 8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 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7498706"/>
                  </a:ext>
                </a:extLst>
              </a:tr>
              <a:tr h="90954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 9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 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7305263"/>
                  </a:ext>
                </a:extLst>
              </a:tr>
              <a:tr h="90954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065492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ck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 1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 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ck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5576105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 2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 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0661867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 3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 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0527651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 4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 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4764887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 5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 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6312238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G 6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H 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1055362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 7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 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5461083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 8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 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8083135"/>
                  </a:ext>
                </a:extLst>
              </a:tr>
              <a:tr h="90954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 9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 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3465100"/>
                  </a:ext>
                </a:extLst>
              </a:tr>
              <a:tr h="90954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0041719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ck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 1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 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ck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6817435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 2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 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3637977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 3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 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1266008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 4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 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2936902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 5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 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355798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 6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K 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5020022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 7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 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0656277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 8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 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000328"/>
                  </a:ext>
                </a:extLst>
              </a:tr>
              <a:tr h="90954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 9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 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3023621"/>
                  </a:ext>
                </a:extLst>
              </a:tr>
              <a:tr h="90954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7722207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ck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 1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 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ck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0694711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 2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 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6090934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 3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 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1158138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 4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 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0888408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 5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 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2880955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L 6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M 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4663237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 7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 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1465977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 8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 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0622512"/>
                  </a:ext>
                </a:extLst>
              </a:tr>
              <a:tr h="90954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 9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 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4045098"/>
                  </a:ext>
                </a:extLst>
              </a:tr>
              <a:tr h="90954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9731629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ck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 1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 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lock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3070712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 2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 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0538289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 3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 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0338993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 4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 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8895152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 5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 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6745887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N 6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O 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0289536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 7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 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1943067"/>
                  </a:ext>
                </a:extLst>
              </a:tr>
              <a:tr h="8792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 8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 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8694123"/>
                  </a:ext>
                </a:extLst>
              </a:tr>
              <a:tr h="90954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 9</a:t>
                      </a:r>
                    </a:p>
                  </a:txBody>
                  <a:tcPr marL="3032" marR="3032" marT="3032" marB="0" anchor="b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 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3032" marR="3032" marT="3032" marB="0" anchor="ctr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x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3032" marR="3032" marT="3032" marB="0" anchor="ctr">
                    <a:lnL>
                      <a:noFill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32" marR="3032" marT="303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1320895"/>
                  </a:ext>
                </a:extLst>
              </a:tr>
            </a:tbl>
          </a:graphicData>
        </a:graphic>
      </p:graphicFrame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B3DA59E5-63DE-4650-BA02-052C1AA236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6770896"/>
              </p:ext>
            </p:extLst>
          </p:nvPr>
        </p:nvGraphicFramePr>
        <p:xfrm>
          <a:off x="4494526" y="786408"/>
          <a:ext cx="1540134" cy="292081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5231">
                  <a:extLst>
                    <a:ext uri="{9D8B030D-6E8A-4147-A177-3AD203B41FA5}">
                      <a16:colId xmlns:a16="http://schemas.microsoft.com/office/drawing/2014/main" val="3119131114"/>
                    </a:ext>
                  </a:extLst>
                </a:gridCol>
                <a:gridCol w="749796">
                  <a:extLst>
                    <a:ext uri="{9D8B030D-6E8A-4147-A177-3AD203B41FA5}">
                      <a16:colId xmlns:a16="http://schemas.microsoft.com/office/drawing/2014/main" val="2212495361"/>
                    </a:ext>
                  </a:extLst>
                </a:gridCol>
                <a:gridCol w="215107">
                  <a:extLst>
                    <a:ext uri="{9D8B030D-6E8A-4147-A177-3AD203B41FA5}">
                      <a16:colId xmlns:a16="http://schemas.microsoft.com/office/drawing/2014/main" val="3298271866"/>
                    </a:ext>
                  </a:extLst>
                </a:gridCol>
              </a:tblGrid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I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</a:rPr>
                        <a:t>Construc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</a:rPr>
                        <a:t>Lin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3385751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</a:rPr>
                        <a:t>35S:RWA-CD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4172116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35S:RWA-CD</a:t>
                      </a:r>
                      <a:endParaRPr kumimoji="0" lang="en-US" sz="800" b="0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1192287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35S:RWA-CD</a:t>
                      </a:r>
                      <a:endParaRPr kumimoji="0" lang="en-US" sz="800" b="0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8283472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</a:rPr>
                        <a:t>35S:AnAXE1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7916083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35S:AnAXE1</a:t>
                      </a:r>
                      <a:endParaRPr kumimoji="0" lang="en-US" sz="800" b="0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0875098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35S:AnAXE1</a:t>
                      </a:r>
                      <a:endParaRPr kumimoji="0" lang="en-US" sz="800" b="0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414984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</a:rPr>
                        <a:t>35S:HjAX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54357"/>
                  </a:ext>
                </a:extLst>
              </a:tr>
              <a:tr h="136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1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35S:HjAXE</a:t>
                      </a:r>
                      <a:endParaRPr kumimoji="0" lang="en-US" sz="800" b="0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404381"/>
                  </a:ext>
                </a:extLst>
              </a:tr>
              <a:tr h="136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35S:HjAXE</a:t>
                      </a:r>
                      <a:endParaRPr kumimoji="0" lang="en-US" sz="800" b="0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2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310548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</a:rPr>
                        <a:t>non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W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94336619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</a:rPr>
                        <a:t>WP:G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926897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</a:rPr>
                        <a:t>WP:G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2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58713200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</a:rPr>
                        <a:t>WP:RWA-ABCD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1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9519328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</a:rPr>
                        <a:t>WP:RWA-ABCD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1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5082212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</a:rPr>
                        <a:t>WP:AnAXE1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2418901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</a:rPr>
                        <a:t>WP:AnAXE1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7449504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</a:rPr>
                        <a:t>WP:AnAXE1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71451496"/>
                  </a:ext>
                </a:extLst>
              </a:tr>
              <a:tr h="136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</a:rPr>
                        <a:t>WP:AnAXE1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0021762"/>
                  </a:ext>
                </a:extLst>
              </a:tr>
              <a:tr h="1364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err="1">
                          <a:effectLst/>
                        </a:rPr>
                        <a:t>WP:HjAXE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1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4642577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WP:HjAXE</a:t>
                      </a:r>
                      <a:endParaRPr kumimoji="0" lang="en-US" sz="800" b="0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14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951341"/>
                  </a:ext>
                </a:extLst>
              </a:tr>
              <a:tr h="1319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WP:HjAXE</a:t>
                      </a:r>
                      <a:endParaRPr kumimoji="0" lang="en-US" sz="800" b="0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14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2597777"/>
                  </a:ext>
                </a:extLst>
              </a:tr>
            </a:tbl>
          </a:graphicData>
        </a:graphic>
      </p:graphicFrame>
      <p:grpSp>
        <p:nvGrpSpPr>
          <p:cNvPr id="20" name="Group 19">
            <a:extLst>
              <a:ext uri="{FF2B5EF4-FFF2-40B4-BE49-F238E27FC236}">
                <a16:creationId xmlns:a16="http://schemas.microsoft.com/office/drawing/2014/main" id="{89CB6378-8C40-4601-AFDC-00F2C0052203}"/>
              </a:ext>
            </a:extLst>
          </p:cNvPr>
          <p:cNvGrpSpPr/>
          <p:nvPr/>
        </p:nvGrpSpPr>
        <p:grpSpPr>
          <a:xfrm>
            <a:off x="558842" y="214646"/>
            <a:ext cx="333746" cy="515257"/>
            <a:chOff x="558842" y="214646"/>
            <a:chExt cx="333746" cy="515257"/>
          </a:xfrm>
        </p:grpSpPr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CE545B74-B76E-4EB0-92F1-664A66D1D220}"/>
                </a:ext>
              </a:extLst>
            </p:cNvPr>
            <p:cNvCxnSpPr/>
            <p:nvPr/>
          </p:nvCxnSpPr>
          <p:spPr>
            <a:xfrm flipV="1">
              <a:off x="725715" y="214646"/>
              <a:ext cx="0" cy="51525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0C99F1E-CB8B-42BE-BAC2-36C480F599AB}"/>
                </a:ext>
              </a:extLst>
            </p:cNvPr>
            <p:cNvSpPr txBox="1"/>
            <p:nvPr/>
          </p:nvSpPr>
          <p:spPr>
            <a:xfrm>
              <a:off x="558842" y="318601"/>
              <a:ext cx="3337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950669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rostokąt 10">
            <a:extLst>
              <a:ext uri="{FF2B5EF4-FFF2-40B4-BE49-F238E27FC236}">
                <a16:creationId xmlns:a16="http://schemas.microsoft.com/office/drawing/2014/main" id="{CEF6270C-AC76-8F45-9AE5-C1F23B3289A0}"/>
              </a:ext>
            </a:extLst>
          </p:cNvPr>
          <p:cNvSpPr/>
          <p:nvPr/>
        </p:nvSpPr>
        <p:spPr>
          <a:xfrm>
            <a:off x="615536" y="7601713"/>
            <a:ext cx="3450713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altLang="en-US" sz="1000" b="1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r>
              <a:rPr lang="en-GB" altLang="en-US" sz="10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  <a:r>
              <a:rPr lang="sv-S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sv-S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wood-specific</a:t>
            </a:r>
            <a:r>
              <a:rPr lang="sv-S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romoter</a:t>
            </a:r>
            <a:r>
              <a:rPr lang="sv-S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(WP) in </a:t>
            </a:r>
            <a:r>
              <a:rPr lang="sv-S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rees</a:t>
            </a:r>
            <a:r>
              <a:rPr lang="sv-S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grown</a:t>
            </a:r>
            <a:r>
              <a:rPr lang="sv-S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sv-S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ield</a:t>
            </a:r>
            <a:r>
              <a:rPr lang="sv-S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  </a:t>
            </a:r>
          </a:p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Histochemical </a:t>
            </a:r>
            <a:r>
              <a:rPr lang="sv-SE" sz="10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glucuronidase analysis of a branch with two-year old cambium from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WP:GU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rees (lines 25 and 27) in the fourth growing season in July, during the active wood production period. X – secondary xylem; P – secondary phloem, S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clereid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PF – phloem fibers; C-vascular cambium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 Activity is seen in cells depositing secondary cell walls (marked with brackets).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EABA996-098E-DA42-9061-3B389B91E23F}"/>
              </a:ext>
            </a:extLst>
          </p:cNvPr>
          <p:cNvGrpSpPr/>
          <p:nvPr/>
        </p:nvGrpSpPr>
        <p:grpSpPr>
          <a:xfrm>
            <a:off x="2340893" y="535159"/>
            <a:ext cx="1395732" cy="6821347"/>
            <a:chOff x="1381524" y="535159"/>
            <a:chExt cx="1395732" cy="6821347"/>
          </a:xfrm>
        </p:grpSpPr>
        <p:pic>
          <p:nvPicPr>
            <p:cNvPr id="20" name="Picture 19" descr="A picture containing indoor, sitting, cat, laying&#10;&#10;Description automatically generated">
              <a:extLst>
                <a:ext uri="{FF2B5EF4-FFF2-40B4-BE49-F238E27FC236}">
                  <a16:creationId xmlns:a16="http://schemas.microsoft.com/office/drawing/2014/main" id="{34A0D167-D357-B643-9E5D-BA7B3D4621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5"/>
            <a:stretch/>
          </p:blipFill>
          <p:spPr>
            <a:xfrm rot="5400000">
              <a:off x="-1343019" y="3259702"/>
              <a:ext cx="6821347" cy="1372261"/>
            </a:xfrm>
            <a:prstGeom prst="rect">
              <a:avLst/>
            </a:prstGeom>
          </p:spPr>
        </p:pic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6B797CF7-032E-A344-B5D4-8E2068449857}"/>
                </a:ext>
              </a:extLst>
            </p:cNvPr>
            <p:cNvGrpSpPr/>
            <p:nvPr/>
          </p:nvGrpSpPr>
          <p:grpSpPr>
            <a:xfrm>
              <a:off x="1600956" y="654739"/>
              <a:ext cx="1176300" cy="6510559"/>
              <a:chOff x="1411599" y="309966"/>
              <a:chExt cx="1176300" cy="6510559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5072D6AD-7C8B-1F40-9DF5-47AD031C5BBC}"/>
                  </a:ext>
                </a:extLst>
              </p:cNvPr>
              <p:cNvGrpSpPr/>
              <p:nvPr/>
            </p:nvGrpSpPr>
            <p:grpSpPr>
              <a:xfrm>
                <a:off x="1411599" y="309966"/>
                <a:ext cx="1176300" cy="6510559"/>
                <a:chOff x="651938" y="429235"/>
                <a:chExt cx="1176300" cy="6510559"/>
              </a:xfrm>
            </p:grpSpPr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96BA3EAB-195F-9644-8C40-F5D5E6665597}"/>
                    </a:ext>
                  </a:extLst>
                </p:cNvPr>
                <p:cNvSpPr txBox="1"/>
                <p:nvPr/>
              </p:nvSpPr>
              <p:spPr>
                <a:xfrm>
                  <a:off x="651938" y="429235"/>
                  <a:ext cx="968535" cy="6463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i="1" dirty="0">
                      <a:solidFill>
                        <a:schemeClr val="bg1"/>
                      </a:solidFill>
                    </a:rPr>
                    <a:t>WP:GUS</a:t>
                  </a:r>
                </a:p>
                <a:p>
                  <a:pPr algn="ctr"/>
                  <a:r>
                    <a:rPr lang="en-US" i="1" dirty="0">
                      <a:solidFill>
                        <a:schemeClr val="bg1"/>
                      </a:solidFill>
                    </a:rPr>
                    <a:t>Line 27</a:t>
                  </a: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0692A738-D080-424A-A96D-05BF5C21830E}"/>
                    </a:ext>
                  </a:extLst>
                </p:cNvPr>
                <p:cNvSpPr txBox="1"/>
                <p:nvPr/>
              </p:nvSpPr>
              <p:spPr>
                <a:xfrm>
                  <a:off x="1274453" y="2900770"/>
                  <a:ext cx="33534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PF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49E9E64C-032C-9241-998D-C6F9069FE56F}"/>
                    </a:ext>
                  </a:extLst>
                </p:cNvPr>
                <p:cNvSpPr txBox="1"/>
                <p:nvPr/>
              </p:nvSpPr>
              <p:spPr>
                <a:xfrm>
                  <a:off x="1492890" y="3605792"/>
                  <a:ext cx="33534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1"/>
                      </a:solidFill>
                    </a:rPr>
                    <a:t>C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66E650FC-869B-BF4D-A815-C1312DE3AA2C}"/>
                    </a:ext>
                  </a:extLst>
                </p:cNvPr>
                <p:cNvSpPr txBox="1"/>
                <p:nvPr/>
              </p:nvSpPr>
              <p:spPr>
                <a:xfrm>
                  <a:off x="1517976" y="4646617"/>
                  <a:ext cx="26481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1"/>
                      </a:solidFill>
                    </a:rPr>
                    <a:t>X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A135CC56-40DA-3B4D-90D2-69F37398F56E}"/>
                    </a:ext>
                  </a:extLst>
                </p:cNvPr>
                <p:cNvSpPr txBox="1"/>
                <p:nvPr/>
              </p:nvSpPr>
              <p:spPr>
                <a:xfrm>
                  <a:off x="1349762" y="3408932"/>
                  <a:ext cx="18473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1"/>
                      </a:solidFill>
                    </a:rPr>
                    <a:t>P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84EE4C5E-0CE6-D44E-8496-D628BB7DBFDA}"/>
                    </a:ext>
                  </a:extLst>
                </p:cNvPr>
                <p:cNvSpPr txBox="1"/>
                <p:nvPr/>
              </p:nvSpPr>
              <p:spPr>
                <a:xfrm>
                  <a:off x="956210" y="1207981"/>
                  <a:ext cx="2551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S</a:t>
                  </a:r>
                </a:p>
              </p:txBody>
            </p:sp>
            <p:cxnSp>
              <p:nvCxnSpPr>
                <p:cNvPr id="18" name="Straight Connector 17">
                  <a:extLst>
                    <a:ext uri="{FF2B5EF4-FFF2-40B4-BE49-F238E27FC236}">
                      <a16:creationId xmlns:a16="http://schemas.microsoft.com/office/drawing/2014/main" id="{E266A64F-3216-6449-9F19-FA42F4141E5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719231" y="3775005"/>
                  <a:ext cx="16861" cy="3164789"/>
                </a:xfrm>
                <a:prstGeom prst="line">
                  <a:avLst/>
                </a:prstGeom>
                <a:ln w="28575">
                  <a:solidFill>
                    <a:schemeClr val="bg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" name="Right Bracket 6">
                <a:extLst>
                  <a:ext uri="{FF2B5EF4-FFF2-40B4-BE49-F238E27FC236}">
                    <a16:creationId xmlns:a16="http://schemas.microsoft.com/office/drawing/2014/main" id="{B1A990A0-5D56-0E4F-95B6-9187A226D294}"/>
                  </a:ext>
                </a:extLst>
              </p:cNvPr>
              <p:cNvSpPr/>
              <p:nvPr/>
            </p:nvSpPr>
            <p:spPr>
              <a:xfrm>
                <a:off x="1721078" y="3452527"/>
                <a:ext cx="45719" cy="727075"/>
              </a:xfrm>
              <a:prstGeom prst="rightBracket">
                <a:avLst/>
              </a:prstGeom>
              <a:ln w="28575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Right Bracket 7">
                <a:extLst>
                  <a:ext uri="{FF2B5EF4-FFF2-40B4-BE49-F238E27FC236}">
                    <a16:creationId xmlns:a16="http://schemas.microsoft.com/office/drawing/2014/main" id="{A36D4049-C92A-9F49-891F-955045BD1DC3}"/>
                  </a:ext>
                </a:extLst>
              </p:cNvPr>
              <p:cNvSpPr/>
              <p:nvPr/>
            </p:nvSpPr>
            <p:spPr>
              <a:xfrm>
                <a:off x="1920958" y="2726636"/>
                <a:ext cx="50111" cy="331864"/>
              </a:xfrm>
              <a:prstGeom prst="rightBracket">
                <a:avLst/>
              </a:prstGeom>
              <a:ln w="28575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" name="Right Bracket 8">
                <a:extLst>
                  <a:ext uri="{FF2B5EF4-FFF2-40B4-BE49-F238E27FC236}">
                    <a16:creationId xmlns:a16="http://schemas.microsoft.com/office/drawing/2014/main" id="{D0CEC59A-8A9C-CE45-B12B-FA62E61D887A}"/>
                  </a:ext>
                </a:extLst>
              </p:cNvPr>
              <p:cNvSpPr/>
              <p:nvPr/>
            </p:nvSpPr>
            <p:spPr>
              <a:xfrm>
                <a:off x="2410045" y="3284081"/>
                <a:ext cx="50110" cy="104012"/>
              </a:xfrm>
              <a:prstGeom prst="rightBracket">
                <a:avLst/>
              </a:prstGeom>
              <a:ln w="28575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Right Bracket 9">
                <a:extLst>
                  <a:ext uri="{FF2B5EF4-FFF2-40B4-BE49-F238E27FC236}">
                    <a16:creationId xmlns:a16="http://schemas.microsoft.com/office/drawing/2014/main" id="{EB549B97-9110-3F45-95D8-6A19911E0388}"/>
                  </a:ext>
                </a:extLst>
              </p:cNvPr>
              <p:cNvSpPr/>
              <p:nvPr/>
            </p:nvSpPr>
            <p:spPr>
              <a:xfrm>
                <a:off x="2346602" y="1828186"/>
                <a:ext cx="45719" cy="230102"/>
              </a:xfrm>
              <a:prstGeom prst="rightBracket">
                <a:avLst/>
              </a:prstGeom>
              <a:ln w="28575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210CA30D-D503-3D46-B4A4-52DFA35DD0A2}"/>
              </a:ext>
            </a:extLst>
          </p:cNvPr>
          <p:cNvGrpSpPr/>
          <p:nvPr/>
        </p:nvGrpSpPr>
        <p:grpSpPr>
          <a:xfrm>
            <a:off x="756225" y="516834"/>
            <a:ext cx="1389701" cy="6858000"/>
            <a:chOff x="1200985" y="78147"/>
            <a:chExt cx="1389701" cy="6858000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9BEFD743-11B8-234B-B99B-F2DDACC0E546}"/>
                </a:ext>
              </a:extLst>
            </p:cNvPr>
            <p:cNvGrpSpPr/>
            <p:nvPr/>
          </p:nvGrpSpPr>
          <p:grpSpPr>
            <a:xfrm>
              <a:off x="1200985" y="78147"/>
              <a:ext cx="1389701" cy="6858000"/>
              <a:chOff x="441324" y="197416"/>
              <a:chExt cx="1389701" cy="6858000"/>
            </a:xfrm>
          </p:grpSpPr>
          <p:pic>
            <p:nvPicPr>
              <p:cNvPr id="26" name="Picture 25" descr="A picture containing cat&#10;&#10;Description automatically generated">
                <a:extLst>
                  <a:ext uri="{FF2B5EF4-FFF2-40B4-BE49-F238E27FC236}">
                    <a16:creationId xmlns:a16="http://schemas.microsoft.com/office/drawing/2014/main" id="{1ABE80B0-5BCE-4B4F-980D-AD71C74EBD1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5400000">
                <a:off x="-2292825" y="2931565"/>
                <a:ext cx="6858000" cy="1389701"/>
              </a:xfrm>
              <a:prstGeom prst="rect">
                <a:avLst/>
              </a:prstGeom>
            </p:spPr>
          </p:pic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F0EEAC32-5E3D-A443-8C70-63079070F20D}"/>
                  </a:ext>
                </a:extLst>
              </p:cNvPr>
              <p:cNvSpPr txBox="1"/>
              <p:nvPr/>
            </p:nvSpPr>
            <p:spPr>
              <a:xfrm>
                <a:off x="629170" y="224392"/>
                <a:ext cx="968535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i="1" dirty="0"/>
                  <a:t>WP:GUS</a:t>
                </a:r>
              </a:p>
              <a:p>
                <a:pPr algn="ctr"/>
                <a:r>
                  <a:rPr lang="en-US" i="1" dirty="0"/>
                  <a:t>Line 25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F869ECE1-3BA1-3F46-824C-57F1E4ACCCAC}"/>
                  </a:ext>
                </a:extLst>
              </p:cNvPr>
              <p:cNvSpPr txBox="1"/>
              <p:nvPr/>
            </p:nvSpPr>
            <p:spPr>
              <a:xfrm>
                <a:off x="1012734" y="3277868"/>
                <a:ext cx="335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PF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71E0AAA9-B49A-2544-961A-5AD1C98AF176}"/>
                  </a:ext>
                </a:extLst>
              </p:cNvPr>
              <p:cNvSpPr txBox="1"/>
              <p:nvPr/>
            </p:nvSpPr>
            <p:spPr>
              <a:xfrm>
                <a:off x="1492890" y="3605792"/>
                <a:ext cx="3353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C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012FED35-5180-E143-B817-1E7F4461D6F4}"/>
                  </a:ext>
                </a:extLst>
              </p:cNvPr>
              <p:cNvSpPr txBox="1"/>
              <p:nvPr/>
            </p:nvSpPr>
            <p:spPr>
              <a:xfrm>
                <a:off x="1517976" y="4646617"/>
                <a:ext cx="2648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X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EA95510E-440C-3241-B840-2CE54703B1D5}"/>
                  </a:ext>
                </a:extLst>
              </p:cNvPr>
              <p:cNvSpPr txBox="1"/>
              <p:nvPr/>
            </p:nvSpPr>
            <p:spPr>
              <a:xfrm>
                <a:off x="1504226" y="3460417"/>
                <a:ext cx="18473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P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C13F4C0E-3F99-D94A-B702-A45BDCF08287}"/>
                  </a:ext>
                </a:extLst>
              </p:cNvPr>
              <p:cNvSpPr txBox="1"/>
              <p:nvPr/>
            </p:nvSpPr>
            <p:spPr>
              <a:xfrm>
                <a:off x="757536" y="2014431"/>
                <a:ext cx="2551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S</a:t>
                </a:r>
              </a:p>
            </p:txBody>
          </p: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4CDD77AF-FFAF-D147-911D-A5F26A8E19B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736090" y="3775005"/>
                <a:ext cx="1" cy="1960839"/>
              </a:xfrm>
              <a:prstGeom prst="line">
                <a:avLst/>
              </a:prstGeom>
              <a:ln w="28575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" name="Right Bracket 21">
              <a:extLst>
                <a:ext uri="{FF2B5EF4-FFF2-40B4-BE49-F238E27FC236}">
                  <a16:creationId xmlns:a16="http://schemas.microsoft.com/office/drawing/2014/main" id="{A8FBB574-30D6-3049-AE27-A5F14B0DDE5B}"/>
                </a:ext>
              </a:extLst>
            </p:cNvPr>
            <p:cNvSpPr/>
            <p:nvPr/>
          </p:nvSpPr>
          <p:spPr>
            <a:xfrm>
              <a:off x="1570905" y="4009625"/>
              <a:ext cx="57870" cy="520825"/>
            </a:xfrm>
            <a:prstGeom prst="rightBracket">
              <a:avLst/>
            </a:prstGeom>
            <a:ln w="28575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ight Bracket 22">
              <a:extLst>
                <a:ext uri="{FF2B5EF4-FFF2-40B4-BE49-F238E27FC236}">
                  <a16:creationId xmlns:a16="http://schemas.microsoft.com/office/drawing/2014/main" id="{3F1A45BB-0588-784C-BC87-4B0951D2E7A8}"/>
                </a:ext>
              </a:extLst>
            </p:cNvPr>
            <p:cNvSpPr/>
            <p:nvPr/>
          </p:nvSpPr>
          <p:spPr>
            <a:xfrm>
              <a:off x="1581812" y="3184476"/>
              <a:ext cx="57691" cy="453874"/>
            </a:xfrm>
            <a:prstGeom prst="rightBracket">
              <a:avLst/>
            </a:prstGeom>
            <a:ln w="28575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ight Bracket 23">
              <a:extLst>
                <a:ext uri="{FF2B5EF4-FFF2-40B4-BE49-F238E27FC236}">
                  <a16:creationId xmlns:a16="http://schemas.microsoft.com/office/drawing/2014/main" id="{DEAB36BB-D89C-DD4F-8DC8-8AF53BE91AE3}"/>
                </a:ext>
              </a:extLst>
            </p:cNvPr>
            <p:cNvSpPr/>
            <p:nvPr/>
          </p:nvSpPr>
          <p:spPr>
            <a:xfrm>
              <a:off x="2263887" y="2698824"/>
              <a:ext cx="50110" cy="104012"/>
            </a:xfrm>
            <a:prstGeom prst="rightBracket">
              <a:avLst/>
            </a:prstGeom>
            <a:ln w="28575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ight Bracket 24">
              <a:extLst>
                <a:ext uri="{FF2B5EF4-FFF2-40B4-BE49-F238E27FC236}">
                  <a16:creationId xmlns:a16="http://schemas.microsoft.com/office/drawing/2014/main" id="{C835BBDB-9EC5-3943-86B7-887931C9C7FE}"/>
                </a:ext>
              </a:extLst>
            </p:cNvPr>
            <p:cNvSpPr/>
            <p:nvPr/>
          </p:nvSpPr>
          <p:spPr>
            <a:xfrm>
              <a:off x="2092293" y="1803789"/>
              <a:ext cx="50110" cy="104012"/>
            </a:xfrm>
            <a:prstGeom prst="rightBracket">
              <a:avLst/>
            </a:prstGeom>
            <a:ln w="28575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8109731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BC50F8B6E2B1CA4195285C82A0441A46" ma:contentTypeVersion="13" ma:contentTypeDescription="Skapa ett nytt dokument." ma:contentTypeScope="" ma:versionID="23f14f67f5042c7c074f143553cf0dc3">
  <xsd:schema xmlns:xsd="http://www.w3.org/2001/XMLSchema" xmlns:xs="http://www.w3.org/2001/XMLSchema" xmlns:p="http://schemas.microsoft.com/office/2006/metadata/properties" xmlns:ns3="eeb73ef0-171b-431f-9f6c-1d6ec9393abd" xmlns:ns4="609f5bf7-f9f4-4529-974b-ffe2f08aeeaa" targetNamespace="http://schemas.microsoft.com/office/2006/metadata/properties" ma:root="true" ma:fieldsID="bee81eaca62d32ec88ad1db0f31c8dd0" ns3:_="" ns4:_="">
    <xsd:import namespace="eeb73ef0-171b-431f-9f6c-1d6ec9393abd"/>
    <xsd:import namespace="609f5bf7-f9f4-4529-974b-ffe2f08aeea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AutoKeyPoints" minOccurs="0"/>
                <xsd:element ref="ns3:MediaServiceKeyPoints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eb73ef0-171b-431f-9f6c-1d6ec9393ab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AutoKeyPoints" ma:index="11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2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09f5bf7-f9f4-4529-974b-ffe2f08aeeaa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Delat med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Delat med information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Delar tips,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nehållstyp"/>
        <xsd:element ref="dc:title" minOccurs="0" maxOccurs="1" ma:index="4" ma:displayName="Rubrik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4F5766DF-CAD0-47DC-A0C5-93122D639E7E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684DFD8-871B-4DDA-AFCA-C3459CA34B24}">
  <ds:schemaRefs>
    <ds:schemaRef ds:uri="http://purl.org/dc/dcmitype/"/>
    <ds:schemaRef ds:uri="http://purl.org/dc/elements/1.1/"/>
    <ds:schemaRef ds:uri="http://schemas.microsoft.com/office/2006/documentManagement/types"/>
    <ds:schemaRef ds:uri="http://www.w3.org/XML/1998/namespace"/>
    <ds:schemaRef ds:uri="http://schemas.microsoft.com/office/infopath/2007/PartnerControls"/>
    <ds:schemaRef ds:uri="http://purl.org/dc/terms/"/>
    <ds:schemaRef ds:uri="http://schemas.openxmlformats.org/package/2006/metadata/core-properties"/>
    <ds:schemaRef ds:uri="eeb73ef0-171b-431f-9f6c-1d6ec9393abd"/>
    <ds:schemaRef ds:uri="609f5bf7-f9f4-4529-974b-ffe2f08aeeaa"/>
    <ds:schemaRef ds:uri="http://schemas.microsoft.com/office/2006/metadata/properties"/>
  </ds:schemaRefs>
</ds:datastoreItem>
</file>

<file path=customXml/itemProps3.xml><?xml version="1.0" encoding="utf-8"?>
<ds:datastoreItem xmlns:ds="http://schemas.openxmlformats.org/officeDocument/2006/customXml" ds:itemID="{0A3E5E8E-806A-4063-863B-DB455C73CB6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eb73ef0-171b-431f-9f6c-1d6ec9393abd"/>
    <ds:schemaRef ds:uri="609f5bf7-f9f4-4529-974b-ffe2f08aeea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93</TotalTime>
  <Words>1671</Words>
  <Application>Microsoft Office PowerPoint</Application>
  <PresentationFormat>A4 Paper (210x297 mm)</PresentationFormat>
  <Paragraphs>126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+DFc2+Aspen+Semi-qPCR</dc:title>
  <dc:creator>Prashant Pawar</dc:creator>
  <cp:lastModifiedBy>Ewa Mellerowicz</cp:lastModifiedBy>
  <cp:revision>20</cp:revision>
  <dcterms:created xsi:type="dcterms:W3CDTF">2019-11-14T04:02:44Z</dcterms:created>
  <dcterms:modified xsi:type="dcterms:W3CDTF">2020-05-07T12:35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C50F8B6E2B1CA4195285C82A0441A46</vt:lpwstr>
  </property>
</Properties>
</file>